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6" d="100"/>
          <a:sy n="106" d="100"/>
        </p:scale>
        <p:origin x="-798" y="-7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Qing%20Li\Desktop\sRNA%20coverage%20over%20gene_20131110\coverage%20of%20Col\bin_statistics_templat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autoTitleDeleted val="1"/>
    <c:plotArea>
      <c:layout>
        <c:manualLayout>
          <c:layoutTarget val="inner"/>
          <c:xMode val="edge"/>
          <c:yMode val="edge"/>
          <c:x val="0.26873909342413271"/>
          <c:y val="0.18708758627393798"/>
          <c:w val="0.66665496204866292"/>
          <c:h val="0.6135992028774182"/>
        </c:manualLayout>
      </c:layout>
      <c:scatterChart>
        <c:scatterStyle val="smoothMarker"/>
        <c:ser>
          <c:idx val="0"/>
          <c:order val="0"/>
          <c:tx>
            <c:strRef>
              <c:f>Sheet3!$B$1</c:f>
              <c:strCache>
                <c:ptCount val="1"/>
                <c:pt idx="0">
                  <c:v>mean coverage</c:v>
                </c:pt>
              </c:strCache>
            </c:strRef>
          </c:tx>
          <c:marker>
            <c:symbol val="circle"/>
            <c:size val="5"/>
          </c:marker>
          <c:xVal>
            <c:numRef>
              <c:f>Sheet3!$A$2:$A$101</c:f>
              <c:numCache>
                <c:formatCode>General</c:formatCode>
                <c:ptCount val="10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</c:numCache>
            </c:numRef>
          </c:xVal>
          <c:yVal>
            <c:numRef>
              <c:f>Sheet3!$B$2:$B$101</c:f>
              <c:numCache>
                <c:formatCode>0%</c:formatCode>
                <c:ptCount val="100"/>
                <c:pt idx="0">
                  <c:v>3.0759616721552294E-4</c:v>
                </c:pt>
                <c:pt idx="1">
                  <c:v>1.299602090165144E-3</c:v>
                </c:pt>
                <c:pt idx="2">
                  <c:v>8.7404833838897753E-4</c:v>
                </c:pt>
                <c:pt idx="3">
                  <c:v>1.7041029194031735E-3</c:v>
                </c:pt>
                <c:pt idx="4">
                  <c:v>4.6958688069682055E-3</c:v>
                </c:pt>
                <c:pt idx="5">
                  <c:v>4.0837172494695897E-3</c:v>
                </c:pt>
                <c:pt idx="6">
                  <c:v>4.6226410317536919E-3</c:v>
                </c:pt>
                <c:pt idx="7">
                  <c:v>5.2388974103494109E-3</c:v>
                </c:pt>
                <c:pt idx="8">
                  <c:v>5.3095112111544484E-3</c:v>
                </c:pt>
                <c:pt idx="9">
                  <c:v>6.6605707490040491E-3</c:v>
                </c:pt>
                <c:pt idx="10">
                  <c:v>1.0950028977044259E-2</c:v>
                </c:pt>
                <c:pt idx="11">
                  <c:v>1.299454357645056E-2</c:v>
                </c:pt>
                <c:pt idx="12">
                  <c:v>1.1550031671056261E-2</c:v>
                </c:pt>
                <c:pt idx="13">
                  <c:v>9.8205006550117647E-3</c:v>
                </c:pt>
                <c:pt idx="14">
                  <c:v>8.9965034562677557E-3</c:v>
                </c:pt>
                <c:pt idx="15">
                  <c:v>9.3814024042574284E-3</c:v>
                </c:pt>
                <c:pt idx="16">
                  <c:v>1.008506011569605E-2</c:v>
                </c:pt>
                <c:pt idx="17">
                  <c:v>9.8444596595661238E-3</c:v>
                </c:pt>
                <c:pt idx="18">
                  <c:v>1.1277062896003012E-2</c:v>
                </c:pt>
                <c:pt idx="19">
                  <c:v>1.100462506034717E-2</c:v>
                </c:pt>
                <c:pt idx="20">
                  <c:v>1.2843626552463561E-2</c:v>
                </c:pt>
                <c:pt idx="21">
                  <c:v>1.187945939578534E-2</c:v>
                </c:pt>
                <c:pt idx="22">
                  <c:v>1.3317205364156417E-2</c:v>
                </c:pt>
                <c:pt idx="23">
                  <c:v>1.2239159372423477E-2</c:v>
                </c:pt>
                <c:pt idx="24">
                  <c:v>1.2095159284318426E-2</c:v>
                </c:pt>
                <c:pt idx="25">
                  <c:v>1.1552040738390832E-2</c:v>
                </c:pt>
                <c:pt idx="26">
                  <c:v>1.1019085225423183E-2</c:v>
                </c:pt>
                <c:pt idx="27">
                  <c:v>1.2206405355362698E-2</c:v>
                </c:pt>
                <c:pt idx="28">
                  <c:v>1.2197813143847731E-2</c:v>
                </c:pt>
                <c:pt idx="29">
                  <c:v>1.2783933940667607E-2</c:v>
                </c:pt>
                <c:pt idx="30">
                  <c:v>1.1703071870926845E-2</c:v>
                </c:pt>
                <c:pt idx="31">
                  <c:v>1.1964996553060301E-2</c:v>
                </c:pt>
                <c:pt idx="32">
                  <c:v>1.2507219413606553E-2</c:v>
                </c:pt>
                <c:pt idx="33">
                  <c:v>9.5626464148179345E-3</c:v>
                </c:pt>
                <c:pt idx="34">
                  <c:v>9.852199506227545E-3</c:v>
                </c:pt>
                <c:pt idx="35">
                  <c:v>1.1886303696609667E-2</c:v>
                </c:pt>
                <c:pt idx="36">
                  <c:v>1.1427976086549109E-2</c:v>
                </c:pt>
                <c:pt idx="37">
                  <c:v>1.3476952958015438E-2</c:v>
                </c:pt>
                <c:pt idx="38">
                  <c:v>1.26772933719681E-2</c:v>
                </c:pt>
                <c:pt idx="39">
                  <c:v>1.2770415421181581E-2</c:v>
                </c:pt>
                <c:pt idx="40">
                  <c:v>1.1067134806815199E-2</c:v>
                </c:pt>
                <c:pt idx="41">
                  <c:v>1.149719855803351E-2</c:v>
                </c:pt>
                <c:pt idx="42">
                  <c:v>1.0967251398005931E-2</c:v>
                </c:pt>
                <c:pt idx="43">
                  <c:v>1.2449138225858643E-2</c:v>
                </c:pt>
                <c:pt idx="44">
                  <c:v>1.2424056942884483E-2</c:v>
                </c:pt>
                <c:pt idx="45">
                  <c:v>9.7657881473797708E-3</c:v>
                </c:pt>
                <c:pt idx="46">
                  <c:v>1.1052469291192307E-2</c:v>
                </c:pt>
                <c:pt idx="47">
                  <c:v>1.116716690499406E-2</c:v>
                </c:pt>
                <c:pt idx="48">
                  <c:v>1.1660699212582646E-2</c:v>
                </c:pt>
                <c:pt idx="49">
                  <c:v>1.2997536341283263E-2</c:v>
                </c:pt>
                <c:pt idx="50">
                  <c:v>1.4395738646920807E-2</c:v>
                </c:pt>
                <c:pt idx="51">
                  <c:v>1.5743941931373757E-2</c:v>
                </c:pt>
                <c:pt idx="52">
                  <c:v>1.3019505911448421E-2</c:v>
                </c:pt>
                <c:pt idx="53">
                  <c:v>1.4166629432807783E-2</c:v>
                </c:pt>
                <c:pt idx="54">
                  <c:v>1.1703721397189346E-2</c:v>
                </c:pt>
                <c:pt idx="55">
                  <c:v>1.1834870546336784E-2</c:v>
                </c:pt>
                <c:pt idx="56">
                  <c:v>1.415661180582805E-2</c:v>
                </c:pt>
                <c:pt idx="57">
                  <c:v>1.5700518116841786E-2</c:v>
                </c:pt>
                <c:pt idx="58">
                  <c:v>1.5939734896724785E-2</c:v>
                </c:pt>
                <c:pt idx="59">
                  <c:v>1.8148548647279644E-2</c:v>
                </c:pt>
                <c:pt idx="60">
                  <c:v>1.744047663826831E-2</c:v>
                </c:pt>
                <c:pt idx="61">
                  <c:v>1.5044590332850983E-2</c:v>
                </c:pt>
                <c:pt idx="62">
                  <c:v>1.5639578518634688E-2</c:v>
                </c:pt>
                <c:pt idx="63">
                  <c:v>1.3796178761805587E-2</c:v>
                </c:pt>
                <c:pt idx="64">
                  <c:v>1.2557341288712243E-2</c:v>
                </c:pt>
                <c:pt idx="65">
                  <c:v>1.4411463366003357E-2</c:v>
                </c:pt>
                <c:pt idx="66">
                  <c:v>1.1351446598481051E-2</c:v>
                </c:pt>
                <c:pt idx="67">
                  <c:v>9.7144344198432236E-3</c:v>
                </c:pt>
                <c:pt idx="68">
                  <c:v>1.2441613489251695E-2</c:v>
                </c:pt>
                <c:pt idx="69">
                  <c:v>1.152676598374168E-2</c:v>
                </c:pt>
                <c:pt idx="70">
                  <c:v>1.2215358354560621E-2</c:v>
                </c:pt>
                <c:pt idx="71">
                  <c:v>1.095593627644257E-2</c:v>
                </c:pt>
                <c:pt idx="72">
                  <c:v>1.1614803200675783E-2</c:v>
                </c:pt>
                <c:pt idx="73">
                  <c:v>1.1983834649803734E-2</c:v>
                </c:pt>
                <c:pt idx="74">
                  <c:v>1.3365416525270297E-2</c:v>
                </c:pt>
                <c:pt idx="75">
                  <c:v>1.3010119008388195E-2</c:v>
                </c:pt>
                <c:pt idx="76">
                  <c:v>1.24597928433633E-2</c:v>
                </c:pt>
                <c:pt idx="77">
                  <c:v>1.1746966234751981E-2</c:v>
                </c:pt>
                <c:pt idx="78">
                  <c:v>1.2283298829023397E-2</c:v>
                </c:pt>
                <c:pt idx="79">
                  <c:v>1.220271200834072E-2</c:v>
                </c:pt>
                <c:pt idx="80">
                  <c:v>1.0538330116908927E-2</c:v>
                </c:pt>
                <c:pt idx="81">
                  <c:v>9.3745210743861E-3</c:v>
                </c:pt>
                <c:pt idx="82">
                  <c:v>8.2475679721468308E-3</c:v>
                </c:pt>
                <c:pt idx="83">
                  <c:v>5.8949868542471969E-3</c:v>
                </c:pt>
                <c:pt idx="84">
                  <c:v>8.6755403864719506E-3</c:v>
                </c:pt>
                <c:pt idx="85">
                  <c:v>6.9273871228745891E-3</c:v>
                </c:pt>
                <c:pt idx="86">
                  <c:v>5.8553877747029503E-3</c:v>
                </c:pt>
                <c:pt idx="87">
                  <c:v>5.3129818606997394E-3</c:v>
                </c:pt>
                <c:pt idx="88">
                  <c:v>7.4401415745388453E-3</c:v>
                </c:pt>
                <c:pt idx="89">
                  <c:v>6.0606380058651314E-3</c:v>
                </c:pt>
                <c:pt idx="90">
                  <c:v>4.0393554468518833E-3</c:v>
                </c:pt>
                <c:pt idx="91">
                  <c:v>3.2983543625282E-3</c:v>
                </c:pt>
                <c:pt idx="92">
                  <c:v>3.8555539054282708E-3</c:v>
                </c:pt>
                <c:pt idx="93">
                  <c:v>3.5185298212011876E-3</c:v>
                </c:pt>
                <c:pt idx="94">
                  <c:v>4.0623080599885312E-3</c:v>
                </c:pt>
                <c:pt idx="95">
                  <c:v>4.100633440953157E-3</c:v>
                </c:pt>
                <c:pt idx="96">
                  <c:v>3.1685270887997275E-3</c:v>
                </c:pt>
                <c:pt idx="97">
                  <c:v>1.3835889027775047E-3</c:v>
                </c:pt>
                <c:pt idx="98">
                  <c:v>9.1398613998797519E-4</c:v>
                </c:pt>
                <c:pt idx="99">
                  <c:v>1.0475534872731642E-3</c:v>
                </c:pt>
              </c:numCache>
            </c:numRef>
          </c:yVal>
          <c:smooth val="1"/>
        </c:ser>
        <c:axId val="48803200"/>
        <c:axId val="67982848"/>
      </c:scatterChart>
      <c:valAx>
        <c:axId val="48803200"/>
        <c:scaling>
          <c:orientation val="minMax"/>
          <c:max val="100"/>
        </c:scaling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Transcript (5' to 3')</a:t>
                </a:r>
              </a:p>
            </c:rich>
          </c:tx>
          <c:layout/>
        </c:title>
        <c:numFmt formatCode="#,##0" sourceLinked="0"/>
        <c:tickLblPos val="nextTo"/>
        <c:crossAx val="67982848"/>
        <c:crosses val="autoZero"/>
        <c:crossBetween val="midCat"/>
      </c:valAx>
      <c:valAx>
        <c:axId val="67982848"/>
        <c:scaling>
          <c:orientation val="minMax"/>
          <c:max val="3.0000000000000006E-2"/>
        </c:scaling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 dirty="0" smtClean="0"/>
                  <a:t>Small</a:t>
                </a:r>
                <a:r>
                  <a:rPr lang="en-US" b="0" baseline="0" dirty="0" smtClean="0"/>
                  <a:t> RNAs </a:t>
                </a:r>
                <a:r>
                  <a:rPr lang="en-US" b="0" dirty="0" smtClean="0"/>
                  <a:t>mean </a:t>
                </a:r>
                <a:r>
                  <a:rPr lang="en-US" b="0" dirty="0"/>
                  <a:t>coverage</a:t>
                </a:r>
              </a:p>
            </c:rich>
          </c:tx>
          <c:layout>
            <c:manualLayout>
              <c:xMode val="edge"/>
              <c:yMode val="edge"/>
              <c:x val="5.0610058877775411E-3"/>
              <c:y val="0.21305385437931371"/>
            </c:manualLayout>
          </c:layout>
        </c:title>
        <c:numFmt formatCode="0%" sourceLinked="1"/>
        <c:tickLblPos val="nextTo"/>
        <c:crossAx val="48803200"/>
        <c:crosses val="autoZero"/>
        <c:crossBetween val="midCat"/>
        <c:majorUnit val="1.0000000000000007E-2"/>
      </c:valAx>
    </c:plotArea>
    <c:plotVisOnly val="1"/>
  </c:chart>
  <c:txPr>
    <a:bodyPr/>
    <a:lstStyle/>
    <a:p>
      <a:pPr>
        <a:defRPr sz="1000">
          <a:latin typeface="Arial" pitchFamily="34" charset="0"/>
          <a:cs typeface="Arial" pitchFamily="34" charset="0"/>
        </a:defRPr>
      </a:pPr>
      <a:endParaRPr lang="en-US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739744" y="762000"/>
            <a:ext cx="2965856" cy="1295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4" name="TextBox 23"/>
          <p:cNvSpPr txBox="1"/>
          <p:nvPr/>
        </p:nvSpPr>
        <p:spPr>
          <a:xfrm>
            <a:off x="2971800" y="762000"/>
            <a:ext cx="9028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Total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sRNAs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971800" y="1447800"/>
            <a:ext cx="9348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Sense strand</a:t>
            </a:r>
            <a:endParaRPr lang="en-US" sz="10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971800" y="1120001"/>
            <a:ext cx="1133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Antisense strand</a:t>
            </a:r>
            <a:endParaRPr lang="en-US" sz="1000" dirty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4426953" y="457200"/>
            <a:ext cx="166904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Chr1:2,045,723-2,051,511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9" name="Picture 3"/>
          <p:cNvPicPr>
            <a:picLocks noChangeAspect="1" noChangeArrowheads="1"/>
          </p:cNvPicPr>
          <p:nvPr/>
        </p:nvPicPr>
        <p:blipFill>
          <a:blip r:embed="rId3" cstate="print"/>
          <a:srcRect t="5882"/>
          <a:stretch>
            <a:fillRect/>
          </a:stretch>
        </p:blipFill>
        <p:spPr bwMode="auto">
          <a:xfrm>
            <a:off x="990600" y="2895600"/>
            <a:ext cx="2514600" cy="1219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" name="TextBox 29"/>
          <p:cNvSpPr txBox="1"/>
          <p:nvPr/>
        </p:nvSpPr>
        <p:spPr>
          <a:xfrm>
            <a:off x="214745" y="2898001"/>
            <a:ext cx="9028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Total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sRNAs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14745" y="3583801"/>
            <a:ext cx="9348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Sense strand</a:t>
            </a:r>
            <a:endParaRPr lang="en-US" sz="10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214745" y="3256002"/>
            <a:ext cx="1133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Antisense strand</a:t>
            </a:r>
            <a:endParaRPr lang="en-US" sz="1000" dirty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1386320" y="2649379"/>
            <a:ext cx="166904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Chr4:6,100,342-6,102,108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5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657600" y="2819400"/>
            <a:ext cx="3048000" cy="1295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0" name="Rectangle 39"/>
          <p:cNvSpPr/>
          <p:nvPr/>
        </p:nvSpPr>
        <p:spPr>
          <a:xfrm>
            <a:off x="4191000" y="2590800"/>
            <a:ext cx="181011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Chr5:26,568,182-26,570,747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41" name="Chart 40"/>
          <p:cNvGraphicFramePr/>
          <p:nvPr/>
        </p:nvGraphicFramePr>
        <p:xfrm>
          <a:off x="152400" y="228600"/>
          <a:ext cx="2819400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42" name="TextBox 41"/>
          <p:cNvSpPr txBox="1"/>
          <p:nvPr/>
        </p:nvSpPr>
        <p:spPr>
          <a:xfrm>
            <a:off x="76200" y="3048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A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861846" y="3048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B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76200" y="25262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C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3382422" y="25262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D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0</Words>
  <Application>Microsoft Office PowerPoint</Application>
  <PresentationFormat>A4 Paper (210x297 mm)</PresentationFormat>
  <Paragraphs>1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Qing Li</dc:creator>
  <cp:lastModifiedBy>Qing Li-Lin Li Home</cp:lastModifiedBy>
  <cp:revision>5</cp:revision>
  <dcterms:created xsi:type="dcterms:W3CDTF">2006-08-16T00:00:00Z</dcterms:created>
  <dcterms:modified xsi:type="dcterms:W3CDTF">2015-04-05T21:33:59Z</dcterms:modified>
</cp:coreProperties>
</file>